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68" r:id="rId2"/>
    <p:sldId id="262" r:id="rId3"/>
  </p:sldIdLst>
  <p:sldSz cx="8229600" cy="9753600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FF"/>
    <a:srgbClr val="3366FF"/>
    <a:srgbClr val="0000FF"/>
    <a:srgbClr val="6600FF"/>
    <a:srgbClr val="FF5050"/>
    <a:srgbClr val="00FFFF"/>
    <a:srgbClr val="FF3300"/>
    <a:srgbClr val="CCECFF"/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56" autoAdjust="0"/>
    <p:restoredTop sz="96671" autoAdjust="0"/>
  </p:normalViewPr>
  <p:slideViewPr>
    <p:cSldViewPr snapToGrid="0">
      <p:cViewPr varScale="1">
        <p:scale>
          <a:sx n="68" d="100"/>
          <a:sy n="68" d="100"/>
        </p:scale>
        <p:origin x="40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BD04CA-6101-4C0F-A37B-251AE2D3F8F5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1162050"/>
            <a:ext cx="264795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575"/>
            <a:ext cx="548640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7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9D227E-D1BA-4969-9702-3EC810984E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5858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1596249"/>
            <a:ext cx="6995160" cy="3395698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22898"/>
            <a:ext cx="6172200" cy="2354862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860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545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519289"/>
            <a:ext cx="1774508" cy="82657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519289"/>
            <a:ext cx="5220653" cy="82657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40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109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2431629"/>
            <a:ext cx="7098030" cy="4057226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6527239"/>
            <a:ext cx="7098030" cy="2133599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210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2596444"/>
            <a:ext cx="3497580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2596444"/>
            <a:ext cx="3497580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658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519291"/>
            <a:ext cx="7098030" cy="188524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2390987"/>
            <a:ext cx="3481506" cy="1171786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3562773"/>
            <a:ext cx="3481506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2390987"/>
            <a:ext cx="3498652" cy="1171786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3562773"/>
            <a:ext cx="3498652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320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740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171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50240"/>
            <a:ext cx="2654260" cy="227584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404340"/>
            <a:ext cx="4166235" cy="6931378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926080"/>
            <a:ext cx="2654260" cy="5420925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002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50240"/>
            <a:ext cx="2654260" cy="227584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404340"/>
            <a:ext cx="4166235" cy="6931378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2926080"/>
            <a:ext cx="2654260" cy="5420925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8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519291"/>
            <a:ext cx="7098030" cy="18852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2596444"/>
            <a:ext cx="7098030" cy="61885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9040144"/>
            <a:ext cx="1851660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827C2-FA1B-4BBB-94E0-5715F380B6B0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9040144"/>
            <a:ext cx="2777490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9040144"/>
            <a:ext cx="1851660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EBD0AD-2458-4B71-B020-49472458A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41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26" Type="http://schemas.openxmlformats.org/officeDocument/2006/relationships/image" Target="../media/image25.png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5" Type="http://schemas.openxmlformats.org/officeDocument/2006/relationships/image" Target="../media/image24.png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24" Type="http://schemas.openxmlformats.org/officeDocument/2006/relationships/image" Target="../media/image23.png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png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13" Type="http://schemas.openxmlformats.org/officeDocument/2006/relationships/image" Target="../media/image37.emf"/><Relationship Id="rId3" Type="http://schemas.openxmlformats.org/officeDocument/2006/relationships/image" Target="../media/image27.tif"/><Relationship Id="rId7" Type="http://schemas.openxmlformats.org/officeDocument/2006/relationships/image" Target="../media/image31.emf"/><Relationship Id="rId12" Type="http://schemas.openxmlformats.org/officeDocument/2006/relationships/image" Target="../media/image36.emf"/><Relationship Id="rId2" Type="http://schemas.openxmlformats.org/officeDocument/2006/relationships/image" Target="../media/image26.tif"/><Relationship Id="rId16" Type="http://schemas.openxmlformats.org/officeDocument/2006/relationships/image" Target="../media/image4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emf"/><Relationship Id="rId11" Type="http://schemas.openxmlformats.org/officeDocument/2006/relationships/image" Target="../media/image35.emf"/><Relationship Id="rId5" Type="http://schemas.openxmlformats.org/officeDocument/2006/relationships/image" Target="../media/image29.emf"/><Relationship Id="rId15" Type="http://schemas.openxmlformats.org/officeDocument/2006/relationships/image" Target="../media/image39.emf"/><Relationship Id="rId10" Type="http://schemas.openxmlformats.org/officeDocument/2006/relationships/image" Target="../media/image34.emf"/><Relationship Id="rId4" Type="http://schemas.openxmlformats.org/officeDocument/2006/relationships/image" Target="../media/image28.emf"/><Relationship Id="rId9" Type="http://schemas.openxmlformats.org/officeDocument/2006/relationships/image" Target="../media/image33.emf"/><Relationship Id="rId14" Type="http://schemas.openxmlformats.org/officeDocument/2006/relationships/image" Target="../media/image3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2970F8F-F620-DEA0-02FC-E93221CA23F6}"/>
              </a:ext>
            </a:extLst>
          </p:cNvPr>
          <p:cNvSpPr txBox="1"/>
          <p:nvPr/>
        </p:nvSpPr>
        <p:spPr>
          <a:xfrm>
            <a:off x="632811" y="23631"/>
            <a:ext cx="74841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72" b="1" dirty="0"/>
              <a:t>Supplemental Figure 1. </a:t>
            </a:r>
            <a:r>
              <a:rPr lang="en-US" dirty="0"/>
              <a:t>Developmental parameters for PTOA and aging OA mice</a:t>
            </a:r>
            <a:r>
              <a:rPr lang="en-US" sz="1600" dirty="0"/>
              <a:t>.</a:t>
            </a:r>
            <a:endParaRPr lang="en-US" sz="1772" b="1" dirty="0"/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19456827-D079-565E-C3D2-55312727A0C5}"/>
              </a:ext>
            </a:extLst>
          </p:cNvPr>
          <p:cNvGrpSpPr/>
          <p:nvPr/>
        </p:nvGrpSpPr>
        <p:grpSpPr>
          <a:xfrm>
            <a:off x="544258" y="891320"/>
            <a:ext cx="7231210" cy="6782763"/>
            <a:chOff x="544258" y="891320"/>
            <a:chExt cx="7231210" cy="6782763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089536A1-6794-301B-3E27-67F4C64D908F}"/>
                </a:ext>
              </a:extLst>
            </p:cNvPr>
            <p:cNvGrpSpPr/>
            <p:nvPr/>
          </p:nvGrpSpPr>
          <p:grpSpPr>
            <a:xfrm>
              <a:off x="632811" y="3229428"/>
              <a:ext cx="3405669" cy="1371321"/>
              <a:chOff x="128219" y="2010567"/>
              <a:chExt cx="3405669" cy="1371321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D4166638-4320-9370-859F-AD4BA5DD659A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 rotWithShape="1">
              <a:blip r:embed="rId2"/>
              <a:srcRect b="24293"/>
              <a:stretch/>
            </p:blipFill>
            <p:spPr>
              <a:xfrm>
                <a:off x="128219" y="2080659"/>
                <a:ext cx="1156588" cy="1286265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46375C4C-1E48-3DA6-4512-B72EAAFF3DC6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 rotWithShape="1">
              <a:blip r:embed="rId3"/>
              <a:srcRect b="24829"/>
              <a:stretch/>
            </p:blipFill>
            <p:spPr>
              <a:xfrm>
                <a:off x="1185812" y="2010842"/>
                <a:ext cx="1213137" cy="1370772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0F86DACC-BA0B-61F7-A95F-94E0627FC558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 rotWithShape="1">
              <a:blip r:embed="rId4"/>
              <a:srcRect b="24829"/>
              <a:stretch/>
            </p:blipFill>
            <p:spPr>
              <a:xfrm>
                <a:off x="2297258" y="2010567"/>
                <a:ext cx="1236630" cy="1371321"/>
              </a:xfrm>
              <a:prstGeom prst="rect">
                <a:avLst/>
              </a:prstGeom>
            </p:spPr>
          </p:pic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A0C696F0-8D35-62EC-638A-724E126C8833}"/>
                </a:ext>
              </a:extLst>
            </p:cNvPr>
            <p:cNvGrpSpPr/>
            <p:nvPr/>
          </p:nvGrpSpPr>
          <p:grpSpPr>
            <a:xfrm>
              <a:off x="4197080" y="3205703"/>
              <a:ext cx="3383276" cy="1395046"/>
              <a:chOff x="4101544" y="1959166"/>
              <a:chExt cx="3383276" cy="1395046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945934D4-BADA-8EA8-8E4F-45A9A39A9538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 rotWithShape="1">
              <a:blip r:embed="rId5"/>
              <a:srcRect t="-1" b="25154"/>
              <a:stretch/>
            </p:blipFill>
            <p:spPr>
              <a:xfrm>
                <a:off x="4101544" y="2028406"/>
                <a:ext cx="1172271" cy="1300835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B329DB1F-F7A5-0E7A-DE83-9F48F4AE6795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 rotWithShape="1">
              <a:blip r:embed="rId6"/>
              <a:srcRect b="25127"/>
              <a:stretch/>
            </p:blipFill>
            <p:spPr>
              <a:xfrm>
                <a:off x="5153109" y="1959166"/>
                <a:ext cx="1232096" cy="1395046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7B86DC33-CDFA-0700-22ED-41B4ADADDCB1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 rotWithShape="1">
              <a:blip r:embed="rId7"/>
              <a:srcRect b="25167"/>
              <a:stretch/>
            </p:blipFill>
            <p:spPr>
              <a:xfrm>
                <a:off x="6242887" y="1959166"/>
                <a:ext cx="1241933" cy="1381096"/>
              </a:xfrm>
              <a:prstGeom prst="rect">
                <a:avLst/>
              </a:prstGeom>
            </p:spPr>
          </p:pic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B931770B-6FD0-B5C1-AF78-A18F732F834A}"/>
                </a:ext>
              </a:extLst>
            </p:cNvPr>
            <p:cNvGrpSpPr/>
            <p:nvPr/>
          </p:nvGrpSpPr>
          <p:grpSpPr>
            <a:xfrm>
              <a:off x="4219106" y="6318217"/>
              <a:ext cx="3556362" cy="1331562"/>
              <a:chOff x="4155223" y="3600525"/>
              <a:chExt cx="3556362" cy="1331562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E210C2BB-A906-A98C-CC69-E5335C6CCF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b="12558"/>
              <a:stretch/>
            </p:blipFill>
            <p:spPr>
              <a:xfrm>
                <a:off x="6286968" y="3603784"/>
                <a:ext cx="1424617" cy="1328303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43FA315E-06AB-2DAB-11A3-D273ED7E8F8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b="9208"/>
              <a:stretch/>
            </p:blipFill>
            <p:spPr>
              <a:xfrm>
                <a:off x="4155223" y="3661834"/>
                <a:ext cx="1290816" cy="1264855"/>
              </a:xfrm>
              <a:prstGeom prst="rect">
                <a:avLst/>
              </a:prstGeom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CEC7E9BA-96B4-2CDD-5443-D6E8268906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b="12558"/>
              <a:stretch/>
            </p:blipFill>
            <p:spPr>
              <a:xfrm>
                <a:off x="5192481" y="3600525"/>
                <a:ext cx="1401006" cy="1328303"/>
              </a:xfrm>
              <a:prstGeom prst="rect">
                <a:avLst/>
              </a:prstGeom>
            </p:spPr>
          </p:pic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69086966-11DF-67C2-0243-2277FEE1BF4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755574" y="6119070"/>
              <a:ext cx="503803" cy="405195"/>
              <a:chOff x="9986510" y="2381624"/>
              <a:chExt cx="674480" cy="542468"/>
            </a:xfrm>
          </p:grpSpPr>
          <p:sp>
            <p:nvSpPr>
              <p:cNvPr id="45" name="Oval 44">
                <a:extLst>
                  <a:ext uri="{FF2B5EF4-FFF2-40B4-BE49-F238E27FC236}">
                    <a16:creationId xmlns:a16="http://schemas.microsoft.com/office/drawing/2014/main" id="{682DDB7B-C793-9B52-23EB-C32DD3A6CD2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9986510" y="2703190"/>
                <a:ext cx="91440" cy="91440"/>
              </a:xfrm>
              <a:prstGeom prst="ellipse">
                <a:avLst/>
              </a:prstGeom>
              <a:solidFill>
                <a:srgbClr val="00B05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772" dirty="0"/>
              </a:p>
            </p:txBody>
          </p:sp>
          <p:sp>
            <p:nvSpPr>
              <p:cNvPr id="46" name="Oval 45">
                <a:extLst>
                  <a:ext uri="{FF2B5EF4-FFF2-40B4-BE49-F238E27FC236}">
                    <a16:creationId xmlns:a16="http://schemas.microsoft.com/office/drawing/2014/main" id="{2C86041F-21D0-C0CE-F39C-8612EAC4876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9986510" y="2520696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772" dirty="0"/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FE8D8684-AB05-D5FD-0B17-976A4B15093D}"/>
                  </a:ext>
                </a:extLst>
              </p:cNvPr>
              <p:cNvSpPr txBox="1"/>
              <p:nvPr/>
            </p:nvSpPr>
            <p:spPr>
              <a:xfrm>
                <a:off x="10059662" y="2381624"/>
                <a:ext cx="564844" cy="3502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TM-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C5A27C5D-29A7-4481-80A4-DE0C92F984B6}"/>
                  </a:ext>
                </a:extLst>
              </p:cNvPr>
              <p:cNvSpPr txBox="1"/>
              <p:nvPr/>
            </p:nvSpPr>
            <p:spPr>
              <a:xfrm>
                <a:off x="10059662" y="2573853"/>
                <a:ext cx="601328" cy="35023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TM+</a:t>
                </a:r>
              </a:p>
            </p:txBody>
          </p: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1E426060-085B-9639-AAF1-C233204C2A5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755574" y="2996335"/>
              <a:ext cx="782909" cy="407360"/>
              <a:chOff x="9986510" y="2381624"/>
              <a:chExt cx="1035573" cy="538828"/>
            </a:xfrm>
          </p:grpSpPr>
          <p:sp>
            <p:nvSpPr>
              <p:cNvPr id="55" name="Oval 54">
                <a:extLst>
                  <a:ext uri="{FF2B5EF4-FFF2-40B4-BE49-F238E27FC236}">
                    <a16:creationId xmlns:a16="http://schemas.microsoft.com/office/drawing/2014/main" id="{E37EB5D0-0823-41BF-DD7B-444027273DB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9986510" y="2703890"/>
                <a:ext cx="91440" cy="91440"/>
              </a:xfrm>
              <a:prstGeom prst="ellipse">
                <a:avLst/>
              </a:prstGeom>
              <a:solidFill>
                <a:srgbClr val="0070C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772" dirty="0"/>
              </a:p>
            </p:txBody>
          </p:sp>
          <p:sp>
            <p:nvSpPr>
              <p:cNvPr id="56" name="Oval 55">
                <a:extLst>
                  <a:ext uri="{FF2B5EF4-FFF2-40B4-BE49-F238E27FC236}">
                    <a16:creationId xmlns:a16="http://schemas.microsoft.com/office/drawing/2014/main" id="{BC81A9A3-9A1A-9B83-8E74-485AE04293A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9986510" y="2520696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772" dirty="0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72610340-86D5-B3C8-2E54-BDC385C0BB96}"/>
                  </a:ext>
                </a:extLst>
              </p:cNvPr>
              <p:cNvSpPr txBox="1"/>
              <p:nvPr/>
            </p:nvSpPr>
            <p:spPr>
              <a:xfrm>
                <a:off x="10025103" y="2381624"/>
                <a:ext cx="960936" cy="3460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MiR-365-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E6B75EA4-AADC-CDA5-DD66-2648C38FF0E7}"/>
                  </a:ext>
                </a:extLst>
              </p:cNvPr>
              <p:cNvSpPr txBox="1"/>
              <p:nvPr/>
            </p:nvSpPr>
            <p:spPr>
              <a:xfrm>
                <a:off x="10025103" y="2574412"/>
                <a:ext cx="996980" cy="3460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/>
                  <a:t>MiR-365+</a:t>
                </a:r>
              </a:p>
            </p:txBody>
          </p:sp>
        </p:grpSp>
        <p:grpSp>
          <p:nvGrpSpPr>
            <p:cNvPr id="120" name="Group 119">
              <a:extLst>
                <a:ext uri="{FF2B5EF4-FFF2-40B4-BE49-F238E27FC236}">
                  <a16:creationId xmlns:a16="http://schemas.microsoft.com/office/drawing/2014/main" id="{CE960F7F-6B44-6A4C-978E-FC4C232DC389}"/>
                </a:ext>
              </a:extLst>
            </p:cNvPr>
            <p:cNvGrpSpPr/>
            <p:nvPr/>
          </p:nvGrpSpPr>
          <p:grpSpPr>
            <a:xfrm>
              <a:off x="4197105" y="1097692"/>
              <a:ext cx="3488801" cy="1598454"/>
              <a:chOff x="4101569" y="906621"/>
              <a:chExt cx="3488801" cy="1598454"/>
            </a:xfrm>
          </p:grpSpPr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74261B0D-988C-0B49-3CDB-9579ACB7E489}"/>
                  </a:ext>
                </a:extLst>
              </p:cNvPr>
              <p:cNvGrpSpPr/>
              <p:nvPr/>
            </p:nvGrpSpPr>
            <p:grpSpPr>
              <a:xfrm>
                <a:off x="4101569" y="1125045"/>
                <a:ext cx="3361763" cy="1380030"/>
                <a:chOff x="4101569" y="619947"/>
                <a:chExt cx="3361763" cy="138003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5857D17C-BEE9-54D2-05B5-64936D7FE711}"/>
                    </a:ext>
                  </a:extLst>
                </p:cNvPr>
                <p:cNvPicPr preferRelativeResize="0">
                  <a:picLocks noChangeAspect="1"/>
                </p:cNvPicPr>
                <p:nvPr/>
              </p:nvPicPr>
              <p:blipFill rotWithShape="1">
                <a:blip r:embed="rId11"/>
                <a:srcRect b="24623"/>
                <a:stretch/>
              </p:blipFill>
              <p:spPr>
                <a:xfrm>
                  <a:off x="4101569" y="679532"/>
                  <a:ext cx="1154459" cy="1320445"/>
                </a:xfrm>
                <a:prstGeom prst="rect">
                  <a:avLst/>
                </a:prstGeom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F2E6B1CC-D644-8132-552A-90FD6A64F048}"/>
                    </a:ext>
                  </a:extLst>
                </p:cNvPr>
                <p:cNvPicPr preferRelativeResize="0">
                  <a:picLocks noChangeAspect="1"/>
                </p:cNvPicPr>
                <p:nvPr/>
              </p:nvPicPr>
              <p:blipFill rotWithShape="1">
                <a:blip r:embed="rId12"/>
                <a:srcRect b="26065"/>
                <a:stretch/>
              </p:blipFill>
              <p:spPr>
                <a:xfrm>
                  <a:off x="5151311" y="619949"/>
                  <a:ext cx="1197757" cy="1371319"/>
                </a:xfrm>
                <a:prstGeom prst="rect">
                  <a:avLst/>
                </a:prstGeom>
              </p:spPr>
            </p:pic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EBC7EB34-B458-AB93-0F73-B07E113552D4}"/>
                    </a:ext>
                  </a:extLst>
                </p:cNvPr>
                <p:cNvGrpSpPr/>
                <p:nvPr/>
              </p:nvGrpSpPr>
              <p:grpSpPr>
                <a:xfrm>
                  <a:off x="6242887" y="619947"/>
                  <a:ext cx="1220445" cy="1371321"/>
                  <a:chOff x="6718468" y="611232"/>
                  <a:chExt cx="1220445" cy="1371321"/>
                </a:xfrm>
              </p:grpSpPr>
              <p:pic>
                <p:nvPicPr>
                  <p:cNvPr id="8" name="Picture 7">
                    <a:extLst>
                      <a:ext uri="{FF2B5EF4-FFF2-40B4-BE49-F238E27FC236}">
                        <a16:creationId xmlns:a16="http://schemas.microsoft.com/office/drawing/2014/main" id="{519CFED3-8181-04D5-26C7-A1B9CE8F28DD}"/>
                      </a:ext>
                    </a:extLst>
                  </p:cNvPr>
                  <p:cNvPicPr preferRelativeResize="0">
                    <a:picLocks noChangeAspect="1"/>
                  </p:cNvPicPr>
                  <p:nvPr/>
                </p:nvPicPr>
                <p:blipFill rotWithShape="1">
                  <a:blip r:embed="rId13"/>
                  <a:srcRect b="26028"/>
                  <a:stretch/>
                </p:blipFill>
                <p:spPr>
                  <a:xfrm>
                    <a:off x="6718468" y="611232"/>
                    <a:ext cx="1220445" cy="1371321"/>
                  </a:xfrm>
                  <a:prstGeom prst="rect">
                    <a:avLst/>
                  </a:prstGeom>
                </p:spPr>
              </p:pic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530AB3B0-C7D3-9076-E15F-B6DAC3AF7DC9}"/>
                      </a:ext>
                    </a:extLst>
                  </p:cNvPr>
                  <p:cNvSpPr txBox="1"/>
                  <p:nvPr/>
                </p:nvSpPr>
                <p:spPr>
                  <a:xfrm>
                    <a:off x="7173960" y="1685688"/>
                    <a:ext cx="764953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i="1" dirty="0"/>
                      <a:t>p = 0.0011 </a:t>
                    </a:r>
                  </a:p>
                </p:txBody>
              </p: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5B92208C-4633-3B7A-5F6C-E6A5B3F485A5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7241448" y="717954"/>
                    <a:ext cx="502618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>
                        <a:solidFill>
                          <a:srgbClr val="FF0000"/>
                        </a:solidFill>
                      </a:rPr>
                      <a:t>**</a:t>
                    </a:r>
                  </a:p>
                  <a:p>
                    <a:pPr algn="ctr"/>
                    <a:endParaRPr lang="en-US" sz="1200" b="1" dirty="0">
                      <a:solidFill>
                        <a:srgbClr val="FF0000"/>
                      </a:solidFill>
                    </a:endParaRPr>
                  </a:p>
                </p:txBody>
              </p:sp>
            </p:grpSp>
          </p:grpSp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FFC76793-0648-651B-9039-F87BDBA7F26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6660038" y="906621"/>
                <a:ext cx="930332" cy="405971"/>
                <a:chOff x="9986510" y="2392695"/>
                <a:chExt cx="1182636" cy="516074"/>
              </a:xfrm>
            </p:grpSpPr>
            <p:sp>
              <p:nvSpPr>
                <p:cNvPr id="50" name="Oval 49">
                  <a:extLst>
                    <a:ext uri="{FF2B5EF4-FFF2-40B4-BE49-F238E27FC236}">
                      <a16:creationId xmlns:a16="http://schemas.microsoft.com/office/drawing/2014/main" id="{43F6C15C-8746-F784-5A49-2DB048BB61E2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986510" y="2706133"/>
                  <a:ext cx="91440" cy="91441"/>
                </a:xfrm>
                <a:prstGeom prst="ellipse">
                  <a:avLst/>
                </a:prstGeom>
                <a:solidFill>
                  <a:srgbClr val="FF0000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772" dirty="0"/>
                </a:p>
              </p:txBody>
            </p:sp>
            <p:sp>
              <p:nvSpPr>
                <p:cNvPr id="51" name="Oval 50">
                  <a:extLst>
                    <a:ext uri="{FF2B5EF4-FFF2-40B4-BE49-F238E27FC236}">
                      <a16:creationId xmlns:a16="http://schemas.microsoft.com/office/drawing/2014/main" id="{A81D29B8-D3E0-B039-731F-3A72220657F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9986510" y="2520696"/>
                  <a:ext cx="91440" cy="91440"/>
                </a:xfrm>
                <a:prstGeom prst="ellipse">
                  <a:avLst/>
                </a:prstGeom>
                <a:solidFill>
                  <a:schemeClr val="bg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772" dirty="0"/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CB90CEB7-1C27-A3CA-92B2-98C042721DC0}"/>
                    </a:ext>
                  </a:extLst>
                </p:cNvPr>
                <p:cNvSpPr txBox="1"/>
                <p:nvPr/>
              </p:nvSpPr>
              <p:spPr>
                <a:xfrm>
                  <a:off x="10015379" y="2392695"/>
                  <a:ext cx="1153767" cy="3325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Non-surgery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1BACE8B5-558F-19C6-C51A-258BC842F699}"/>
                    </a:ext>
                  </a:extLst>
                </p:cNvPr>
                <p:cNvSpPr txBox="1"/>
                <p:nvPr/>
              </p:nvSpPr>
              <p:spPr>
                <a:xfrm>
                  <a:off x="10015379" y="2576208"/>
                  <a:ext cx="803276" cy="3325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Surgery</a:t>
                  </a:r>
                </a:p>
              </p:txBody>
            </p:sp>
          </p:grp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B19CC4FF-F777-9110-6AB1-4B8DF1903F96}"/>
                  </a:ext>
                </a:extLst>
              </p:cNvPr>
              <p:cNvSpPr txBox="1"/>
              <p:nvPr/>
            </p:nvSpPr>
            <p:spPr>
              <a:xfrm>
                <a:off x="4334982" y="976807"/>
                <a:ext cx="59208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PTOA</a:t>
                </a:r>
              </a:p>
            </p:txBody>
          </p: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697CEFE-CCAC-0C25-9FD1-18A7608B720A}"/>
                </a:ext>
              </a:extLst>
            </p:cNvPr>
            <p:cNvSpPr txBox="1"/>
            <p:nvPr/>
          </p:nvSpPr>
          <p:spPr>
            <a:xfrm>
              <a:off x="860393" y="2953652"/>
              <a:ext cx="14436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MiR-365: Female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E828B66-2F6C-7016-2F8F-79319467B593}"/>
                </a:ext>
              </a:extLst>
            </p:cNvPr>
            <p:cNvSpPr txBox="1"/>
            <p:nvPr/>
          </p:nvSpPr>
          <p:spPr>
            <a:xfrm>
              <a:off x="4423569" y="3047204"/>
              <a:ext cx="12859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MiR-365: Male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E2F5BE10-A0FD-BDCF-522A-CC77E99000A4}"/>
                </a:ext>
              </a:extLst>
            </p:cNvPr>
            <p:cNvGrpSpPr/>
            <p:nvPr/>
          </p:nvGrpSpPr>
          <p:grpSpPr>
            <a:xfrm>
              <a:off x="610645" y="6194262"/>
              <a:ext cx="3612253" cy="1479821"/>
              <a:chOff x="610645" y="5716582"/>
              <a:chExt cx="3612253" cy="1479821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318A9120-C58E-D42D-8911-12698127B3F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b="11865"/>
              <a:stretch/>
            </p:blipFill>
            <p:spPr>
              <a:xfrm>
                <a:off x="2775997" y="5813570"/>
                <a:ext cx="1446901" cy="1362385"/>
              </a:xfrm>
              <a:prstGeom prst="rect">
                <a:avLst/>
              </a:prstGeom>
            </p:spPr>
          </p:pic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CBC75094-F9AB-003C-9020-38433DAE91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b="8447"/>
              <a:stretch/>
            </p:blipFill>
            <p:spPr>
              <a:xfrm>
                <a:off x="610645" y="5887816"/>
                <a:ext cx="1324737" cy="1308587"/>
              </a:xfrm>
              <a:prstGeom prst="rect">
                <a:avLst/>
              </a:prstGeom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4DC19416-13A1-17C1-3A29-E3C7765F4E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b="11865"/>
              <a:stretch/>
            </p:blipFill>
            <p:spPr>
              <a:xfrm>
                <a:off x="1692486" y="5829516"/>
                <a:ext cx="1400312" cy="1340760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B22E525-64F3-18C5-F1B9-1F651843DFFD}"/>
                  </a:ext>
                </a:extLst>
              </p:cNvPr>
              <p:cNvSpPr txBox="1"/>
              <p:nvPr/>
            </p:nvSpPr>
            <p:spPr>
              <a:xfrm>
                <a:off x="3220938" y="6906637"/>
                <a:ext cx="73609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i="1" dirty="0"/>
                  <a:t>p = 0.0025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ED1320B-76AB-242F-64A2-86B1688B5B93}"/>
                  </a:ext>
                </a:extLst>
              </p:cNvPr>
              <p:cNvSpPr txBox="1"/>
              <p:nvPr/>
            </p:nvSpPr>
            <p:spPr>
              <a:xfrm>
                <a:off x="3426591" y="5942102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0000"/>
                    </a:solidFill>
                  </a:rPr>
                  <a:t>**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AEFDA05-8AFE-ACAD-2AFA-5B1375163818}"/>
                  </a:ext>
                </a:extLst>
              </p:cNvPr>
              <p:cNvSpPr txBox="1"/>
              <p:nvPr/>
            </p:nvSpPr>
            <p:spPr>
              <a:xfrm>
                <a:off x="860393" y="5716582"/>
                <a:ext cx="105727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TM: Female</a:t>
                </a:r>
              </a:p>
            </p:txBody>
          </p:sp>
        </p:grp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34FB967-B71E-5F21-2E03-FD5E04EAEC27}"/>
                </a:ext>
              </a:extLst>
            </p:cNvPr>
            <p:cNvSpPr txBox="1"/>
            <p:nvPr/>
          </p:nvSpPr>
          <p:spPr>
            <a:xfrm>
              <a:off x="4454844" y="6205279"/>
              <a:ext cx="8996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TM: Male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7BA54F0-BDD6-1ACD-A0A1-54782BE75CFE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55468" y="891320"/>
              <a:ext cx="298333" cy="3376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A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7D624001-5B73-7377-A9C4-2197980B9F9B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55468" y="2906528"/>
              <a:ext cx="327334" cy="365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D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41787DD-7CC3-64F9-A123-B9E05A128AD9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160936" y="892603"/>
              <a:ext cx="295206" cy="3650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772" b="1" dirty="0"/>
                <a:t>C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DE11F88-B799-80D8-93AB-48A11B4870F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55468" y="6159165"/>
              <a:ext cx="328936" cy="365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H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9F606F52-4E2B-39CE-570D-22A8649341F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160936" y="2906528"/>
              <a:ext cx="295274" cy="365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E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FA0A00FF-9BB4-6A09-D1D8-EA30132FD5B0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160936" y="6159165"/>
              <a:ext cx="245580" cy="365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I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05DD84C-B8BE-4EFB-27B3-9411D6500109}"/>
                </a:ext>
              </a:extLst>
            </p:cNvPr>
            <p:cNvSpPr txBox="1"/>
            <p:nvPr/>
          </p:nvSpPr>
          <p:spPr>
            <a:xfrm>
              <a:off x="870001" y="3131542"/>
              <a:ext cx="745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u="sng" dirty="0"/>
                <a:t>5-Month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391ACE1-8DC5-5AB3-8FDD-07D403A58165}"/>
                </a:ext>
              </a:extLst>
            </p:cNvPr>
            <p:cNvSpPr txBox="1"/>
            <p:nvPr/>
          </p:nvSpPr>
          <p:spPr>
            <a:xfrm>
              <a:off x="873666" y="4610876"/>
              <a:ext cx="745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u="sng" dirty="0"/>
                <a:t>3-Month</a:t>
              </a:r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F3FF64A1-7E6F-4746-8AB4-4A7D6C1C4924}"/>
                </a:ext>
              </a:extLst>
            </p:cNvPr>
            <p:cNvGrpSpPr/>
            <p:nvPr/>
          </p:nvGrpSpPr>
          <p:grpSpPr>
            <a:xfrm>
              <a:off x="586686" y="4715222"/>
              <a:ext cx="3443954" cy="1384241"/>
              <a:chOff x="586686" y="4237542"/>
              <a:chExt cx="3443954" cy="1384241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79B4C671-E343-9196-F9FF-F82F63A3BD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/>
              <a:srcRect b="23719"/>
              <a:stretch/>
            </p:blipFill>
            <p:spPr>
              <a:xfrm>
                <a:off x="586686" y="4237542"/>
                <a:ext cx="1215512" cy="1373230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9B01670C-34A8-EC4B-AF70-F14F6C5EF45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b="24094"/>
              <a:stretch/>
            </p:blipFill>
            <p:spPr>
              <a:xfrm>
                <a:off x="1720529" y="4295308"/>
                <a:ext cx="1178560" cy="1326472"/>
              </a:xfrm>
              <a:prstGeom prst="rect">
                <a:avLst/>
              </a:prstGeom>
            </p:spPr>
          </p:pic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F4AE5E4D-3468-B346-9890-2B1F0437EA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b="23795"/>
              <a:stretch/>
            </p:blipFill>
            <p:spPr>
              <a:xfrm>
                <a:off x="2827696" y="4296280"/>
                <a:ext cx="1202944" cy="1325503"/>
              </a:xfrm>
              <a:prstGeom prst="rect">
                <a:avLst/>
              </a:prstGeom>
            </p:spPr>
          </p:pic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219AA1EA-B45C-8048-9510-9272FE63C407}"/>
                </a:ext>
              </a:extLst>
            </p:cNvPr>
            <p:cNvGrpSpPr/>
            <p:nvPr/>
          </p:nvGrpSpPr>
          <p:grpSpPr>
            <a:xfrm>
              <a:off x="4152879" y="4715222"/>
              <a:ext cx="3436176" cy="1388624"/>
              <a:chOff x="4057343" y="4237542"/>
              <a:chExt cx="3436176" cy="1388624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C7D20B51-3433-88C7-499C-F7C4107459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b="23395"/>
              <a:stretch/>
            </p:blipFill>
            <p:spPr>
              <a:xfrm>
                <a:off x="4057343" y="4237542"/>
                <a:ext cx="1216472" cy="1388624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3A523014-88F6-1943-AA44-412035A2FF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b="25200"/>
              <a:stretch/>
            </p:blipFill>
            <p:spPr>
              <a:xfrm>
                <a:off x="5189507" y="4291690"/>
                <a:ext cx="1178560" cy="1319304"/>
              </a:xfrm>
              <a:prstGeom prst="rect">
                <a:avLst/>
              </a:prstGeom>
            </p:spPr>
          </p:pic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813B3C19-B878-344F-B26D-D7BC469390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b="25773"/>
              <a:stretch/>
            </p:blipFill>
            <p:spPr>
              <a:xfrm>
                <a:off x="6290575" y="4287245"/>
                <a:ext cx="1202944" cy="1303165"/>
              </a:xfrm>
              <a:prstGeom prst="rect">
                <a:avLst/>
              </a:prstGeom>
            </p:spPr>
          </p:pic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E19AB880-BBE9-294D-93DF-1E21A33B8700}"/>
                </a:ext>
              </a:extLst>
            </p:cNvPr>
            <p:cNvGrpSpPr/>
            <p:nvPr/>
          </p:nvGrpSpPr>
          <p:grpSpPr>
            <a:xfrm>
              <a:off x="3296071" y="1153524"/>
              <a:ext cx="1033084" cy="1844258"/>
              <a:chOff x="3089206" y="875864"/>
              <a:chExt cx="1033084" cy="1844258"/>
            </a:xfrm>
          </p:grpSpPr>
          <p:pic>
            <p:nvPicPr>
              <p:cNvPr id="70" name="Picture 69">
                <a:extLst>
                  <a:ext uri="{FF2B5EF4-FFF2-40B4-BE49-F238E27FC236}">
                    <a16:creationId xmlns:a16="http://schemas.microsoft.com/office/drawing/2014/main" id="{1C93DC38-1835-72DF-F0AD-7B564F7FD0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l="14388" b="22030"/>
              <a:stretch/>
            </p:blipFill>
            <p:spPr>
              <a:xfrm rot="5400000">
                <a:off x="2916845" y="1633290"/>
                <a:ext cx="1609723" cy="467877"/>
              </a:xfrm>
              <a:prstGeom prst="rect">
                <a:avLst/>
              </a:prstGeom>
            </p:spPr>
          </p:pic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43C9557D-7DF6-4E5A-1287-CA8E5F0DC740}"/>
                  </a:ext>
                </a:extLst>
              </p:cNvPr>
              <p:cNvSpPr txBox="1"/>
              <p:nvPr/>
            </p:nvSpPr>
            <p:spPr>
              <a:xfrm>
                <a:off x="3089206" y="2320012"/>
                <a:ext cx="103308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Developmental Parameters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25FFDB2F-3AAF-CA48-B1E5-5047848ED8FB}"/>
                  </a:ext>
                </a:extLst>
              </p:cNvPr>
              <p:cNvSpPr txBox="1"/>
              <p:nvPr/>
            </p:nvSpPr>
            <p:spPr>
              <a:xfrm>
                <a:off x="3303984" y="875864"/>
                <a:ext cx="73449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rgbClr val="FF0000"/>
                    </a:solidFill>
                  </a:rPr>
                  <a:t>Body width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2DEED10E-4416-9243-AAFD-6845BD965A32}"/>
                  </a:ext>
                </a:extLst>
              </p:cNvPr>
              <p:cNvSpPr txBox="1"/>
              <p:nvPr/>
            </p:nvSpPr>
            <p:spPr>
              <a:xfrm>
                <a:off x="3090964" y="1389218"/>
                <a:ext cx="4908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Body</a:t>
                </a:r>
              </a:p>
              <a:p>
                <a:pPr algn="ctr"/>
                <a:r>
                  <a:rPr lang="en-US" sz="900" b="1" dirty="0"/>
                  <a:t>length</a:t>
                </a:r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51CF0A6A-A69B-284B-AB09-B7A37AF59543}"/>
                </a:ext>
              </a:extLst>
            </p:cNvPr>
            <p:cNvGrpSpPr/>
            <p:nvPr/>
          </p:nvGrpSpPr>
          <p:grpSpPr>
            <a:xfrm>
              <a:off x="544258" y="926420"/>
              <a:ext cx="2761092" cy="2029217"/>
              <a:chOff x="900788" y="7328365"/>
              <a:chExt cx="2761092" cy="2029217"/>
            </a:xfrm>
          </p:grpSpPr>
          <p:pic>
            <p:nvPicPr>
              <p:cNvPr id="99" name="Picture 98">
                <a:extLst>
                  <a:ext uri="{FF2B5EF4-FFF2-40B4-BE49-F238E27FC236}">
                    <a16:creationId xmlns:a16="http://schemas.microsoft.com/office/drawing/2014/main" id="{B8BA8434-C30D-D944-B2C1-82CEBD347C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1500360" y="7577714"/>
                <a:ext cx="216419" cy="495833"/>
              </a:xfrm>
              <a:prstGeom prst="rect">
                <a:avLst/>
              </a:prstGeom>
            </p:spPr>
          </p:pic>
          <p:pic>
            <p:nvPicPr>
              <p:cNvPr id="100" name="Picture 99">
                <a:extLst>
                  <a:ext uri="{FF2B5EF4-FFF2-40B4-BE49-F238E27FC236}">
                    <a16:creationId xmlns:a16="http://schemas.microsoft.com/office/drawing/2014/main" id="{52CDC177-B3F2-F347-B1CF-AFABB4B0DB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2550074" y="7577714"/>
                <a:ext cx="231336" cy="479094"/>
              </a:xfrm>
              <a:prstGeom prst="rect">
                <a:avLst/>
              </a:prstGeom>
            </p:spPr>
          </p:pic>
          <p:pic>
            <p:nvPicPr>
              <p:cNvPr id="101" name="Picture 100">
                <a:extLst>
                  <a:ext uri="{FF2B5EF4-FFF2-40B4-BE49-F238E27FC236}">
                    <a16:creationId xmlns:a16="http://schemas.microsoft.com/office/drawing/2014/main" id="{8B5B2E06-1168-F24D-AEA5-3D1F38D783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2596113" y="8797344"/>
                <a:ext cx="336581" cy="513148"/>
              </a:xfrm>
              <a:prstGeom prst="rect">
                <a:avLst/>
              </a:prstGeom>
            </p:spPr>
          </p:pic>
          <p:pic>
            <p:nvPicPr>
              <p:cNvPr id="102" name="Picture 101">
                <a:extLst>
                  <a:ext uri="{FF2B5EF4-FFF2-40B4-BE49-F238E27FC236}">
                    <a16:creationId xmlns:a16="http://schemas.microsoft.com/office/drawing/2014/main" id="{9C663A4E-C087-434E-BB1F-041A1A6614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1497107" y="8797344"/>
                <a:ext cx="222925" cy="513148"/>
              </a:xfrm>
              <a:prstGeom prst="rect">
                <a:avLst/>
              </a:prstGeom>
            </p:spPr>
          </p:pic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8C146747-5CF5-C845-AB79-F796362546A6}"/>
                  </a:ext>
                </a:extLst>
              </p:cNvPr>
              <p:cNvSpPr txBox="1"/>
              <p:nvPr/>
            </p:nvSpPr>
            <p:spPr>
              <a:xfrm>
                <a:off x="1003380" y="7731148"/>
                <a:ext cx="45236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PTOA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57735556-D980-094C-94B4-28F8393F325A}"/>
                  </a:ext>
                </a:extLst>
              </p:cNvPr>
              <p:cNvSpPr txBox="1"/>
              <p:nvPr/>
            </p:nvSpPr>
            <p:spPr>
              <a:xfrm>
                <a:off x="1648647" y="7557072"/>
                <a:ext cx="971741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Non-surgery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(Unoperated, DMM-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ale (n = 9)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DE0A56F8-54E7-4F43-84A8-ED3B13FCED66}"/>
                  </a:ext>
                </a:extLst>
              </p:cNvPr>
              <p:cNvSpPr txBox="1"/>
              <p:nvPr/>
            </p:nvSpPr>
            <p:spPr>
              <a:xfrm>
                <a:off x="2816717" y="7557074"/>
                <a:ext cx="630301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urgery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(DMM+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ale (n = 7)</a:t>
                </a:r>
                <a:endParaRPr lang="en-US" sz="800" b="1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pic>
            <p:nvPicPr>
              <p:cNvPr id="106" name="Picture 105">
                <a:extLst>
                  <a:ext uri="{FF2B5EF4-FFF2-40B4-BE49-F238E27FC236}">
                    <a16:creationId xmlns:a16="http://schemas.microsoft.com/office/drawing/2014/main" id="{289F9372-49A7-C446-A5D5-FBACD75000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1500360" y="8132716"/>
                <a:ext cx="216419" cy="495833"/>
              </a:xfrm>
              <a:prstGeom prst="rect">
                <a:avLst/>
              </a:prstGeom>
            </p:spPr>
          </p:pic>
          <p:pic>
            <p:nvPicPr>
              <p:cNvPr id="107" name="Picture 106">
                <a:extLst>
                  <a:ext uri="{FF2B5EF4-FFF2-40B4-BE49-F238E27FC236}">
                    <a16:creationId xmlns:a16="http://schemas.microsoft.com/office/drawing/2014/main" id="{DB925B82-F6D0-3345-93ED-2084EFDAD9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2580700" y="8132716"/>
                <a:ext cx="216419" cy="495833"/>
              </a:xfrm>
              <a:prstGeom prst="rect">
                <a:avLst/>
              </a:prstGeom>
            </p:spPr>
          </p:pic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3F1AD8D1-E24E-D944-8AEF-C645B697FDDD}"/>
                  </a:ext>
                </a:extLst>
              </p:cNvPr>
              <p:cNvSpPr txBox="1"/>
              <p:nvPr/>
            </p:nvSpPr>
            <p:spPr>
              <a:xfrm>
                <a:off x="900788" y="8317496"/>
                <a:ext cx="6399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ging-OA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ABF01DD9-3773-B44F-AB5F-7F28FB86566A}"/>
                  </a:ext>
                </a:extLst>
              </p:cNvPr>
              <p:cNvSpPr txBox="1"/>
              <p:nvPr/>
            </p:nvSpPr>
            <p:spPr>
              <a:xfrm>
                <a:off x="900788" y="8924595"/>
                <a:ext cx="6399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Aging-OA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C7DDD6A2-BA21-CA46-B355-D4069D83CA91}"/>
                  </a:ext>
                </a:extLst>
              </p:cNvPr>
              <p:cNvSpPr txBox="1"/>
              <p:nvPr/>
            </p:nvSpPr>
            <p:spPr>
              <a:xfrm>
                <a:off x="1654617" y="8111078"/>
                <a:ext cx="121133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iR-365-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3M: Female (n = 14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       Male (n = 13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5M: Female (n = 11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       Male (n = 11)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829AAE18-BEF3-B444-89D3-D17F2BF703E0}"/>
                  </a:ext>
                </a:extLst>
              </p:cNvPr>
              <p:cNvSpPr txBox="1"/>
              <p:nvPr/>
            </p:nvSpPr>
            <p:spPr>
              <a:xfrm>
                <a:off x="2736627" y="8111078"/>
                <a:ext cx="925253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iR-365+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3M: Female (n = 15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       Male (n = 10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5M: Female (n = 8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       Male (n = 9)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1D6BD7EB-48F7-AB48-A963-93FA811B53D4}"/>
                  </a:ext>
                </a:extLst>
              </p:cNvPr>
              <p:cNvSpPr txBox="1"/>
              <p:nvPr/>
            </p:nvSpPr>
            <p:spPr>
              <a:xfrm>
                <a:off x="1728033" y="8767206"/>
                <a:ext cx="71205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TM-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Female (n = 3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ale (n = 8)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3C5153B9-F80D-0A4E-A84C-3F73A75C9816}"/>
                  </a:ext>
                </a:extLst>
              </p:cNvPr>
              <p:cNvSpPr txBox="1"/>
              <p:nvPr/>
            </p:nvSpPr>
            <p:spPr>
              <a:xfrm>
                <a:off x="2876785" y="8773881"/>
                <a:ext cx="712054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TM+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Female (n = 6)</a:t>
                </a:r>
              </a:p>
              <a:p>
                <a:r>
                  <a:rPr lang="en-US" sz="700" b="1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ale (n = 5)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404C91DD-E5AB-874D-BACA-65B2929F47B3}"/>
                  </a:ext>
                </a:extLst>
              </p:cNvPr>
              <p:cNvSpPr txBox="1"/>
              <p:nvPr/>
            </p:nvSpPr>
            <p:spPr>
              <a:xfrm>
                <a:off x="1697739" y="7328365"/>
                <a:ext cx="63190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u="sng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Controls</a:t>
                </a: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A6767FF5-C6A8-944C-A3D6-725F8ECC3179}"/>
                  </a:ext>
                </a:extLst>
              </p:cNvPr>
              <p:cNvSpPr txBox="1"/>
              <p:nvPr/>
            </p:nvSpPr>
            <p:spPr>
              <a:xfrm>
                <a:off x="2695966" y="7328365"/>
                <a:ext cx="76655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u="sng" dirty="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OA models</a:t>
                </a:r>
              </a:p>
            </p:txBody>
          </p:sp>
          <p:sp>
            <p:nvSpPr>
              <p:cNvPr id="116" name="Rectangle 115">
                <a:extLst>
                  <a:ext uri="{FF2B5EF4-FFF2-40B4-BE49-F238E27FC236}">
                    <a16:creationId xmlns:a16="http://schemas.microsoft.com/office/drawing/2014/main" id="{A74F4079-B334-9542-A202-67EFD39C4EFB}"/>
                  </a:ext>
                </a:extLst>
              </p:cNvPr>
              <p:cNvSpPr/>
              <p:nvPr/>
            </p:nvSpPr>
            <p:spPr>
              <a:xfrm>
                <a:off x="2537629" y="7549143"/>
                <a:ext cx="1068450" cy="180843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7" name="Rectangle 116">
                <a:extLst>
                  <a:ext uri="{FF2B5EF4-FFF2-40B4-BE49-F238E27FC236}">
                    <a16:creationId xmlns:a16="http://schemas.microsoft.com/office/drawing/2014/main" id="{EF34A2B7-7CCD-CA49-9A12-4A953756DC99}"/>
                  </a:ext>
                </a:extLst>
              </p:cNvPr>
              <p:cNvSpPr/>
              <p:nvPr/>
            </p:nvSpPr>
            <p:spPr>
              <a:xfrm>
                <a:off x="1470868" y="7549143"/>
                <a:ext cx="1068450" cy="180843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CE594795-4C98-CB4E-9A2A-B3FEF9177F6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470196" y="8100744"/>
                <a:ext cx="2135883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4E6BC3E0-814E-9449-BCF7-C5884F68099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465125" y="8763770"/>
                <a:ext cx="2135883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C3181D1E-2565-E14E-96D5-44895CD8B42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318747" y="892603"/>
              <a:ext cx="295206" cy="3363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772" b="1" dirty="0"/>
                <a:t>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29E31C4-F5AA-649F-3E86-FE17DB88F03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55468" y="4571829"/>
              <a:ext cx="288862" cy="365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F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06B7590-06E9-D3EB-F44E-6469D4C0628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160936" y="4571829"/>
              <a:ext cx="328936" cy="3650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081089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103660-45C3-7143-7D8F-BC1D53E793A2}"/>
              </a:ext>
            </a:extLst>
          </p:cNvPr>
          <p:cNvSpPr txBox="1"/>
          <p:nvPr/>
        </p:nvSpPr>
        <p:spPr>
          <a:xfrm>
            <a:off x="400640" y="63257"/>
            <a:ext cx="74905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72" b="1" dirty="0"/>
              <a:t>Supplemental Figure 2. </a:t>
            </a:r>
            <a:r>
              <a:rPr lang="en-US" dirty="0"/>
              <a:t>Male inducible aging OA mice does not show OA phenotypes or common gait changes, but with some other gait differences</a:t>
            </a:r>
            <a:r>
              <a:rPr lang="en-US" sz="1772" b="1" dirty="0"/>
              <a:t>.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9DC79268-8B67-6E94-1652-68DC79DF26A3}"/>
              </a:ext>
            </a:extLst>
          </p:cNvPr>
          <p:cNvGrpSpPr/>
          <p:nvPr/>
        </p:nvGrpSpPr>
        <p:grpSpPr>
          <a:xfrm>
            <a:off x="453384" y="789640"/>
            <a:ext cx="4867395" cy="6592161"/>
            <a:chOff x="453384" y="789640"/>
            <a:chExt cx="4867395" cy="6592161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FA05A16-2833-0DF9-69E8-669E68EBC06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53384" y="789640"/>
              <a:ext cx="298333" cy="3376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C49EEA4-A4E0-0CE7-1247-619D6438692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2881190" y="2191180"/>
              <a:ext cx="258563" cy="3095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C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CDC0A8F-53D3-932D-F82B-93BB5D4FDB32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53384" y="2164375"/>
              <a:ext cx="295206" cy="3363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772" b="1" dirty="0"/>
                <a:t>B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ADA0F56-54E8-6BDB-38B2-FD2E7CA9BD1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53384" y="5570432"/>
              <a:ext cx="250406" cy="3095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E</a:t>
              </a:r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11458467-8CA1-196E-3C3F-F373E85021C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647393" y="1014615"/>
              <a:ext cx="480764" cy="409868"/>
              <a:chOff x="9986510" y="2381624"/>
              <a:chExt cx="751188" cy="640419"/>
            </a:xfrm>
          </p:grpSpPr>
          <p:sp>
            <p:nvSpPr>
              <p:cNvPr id="19" name="Oval 18">
                <a:extLst>
                  <a:ext uri="{FF2B5EF4-FFF2-40B4-BE49-F238E27FC236}">
                    <a16:creationId xmlns:a16="http://schemas.microsoft.com/office/drawing/2014/main" id="{67CAC383-469B-E083-FECF-F9F36BB3D7C1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9986510" y="2798598"/>
                <a:ext cx="91440" cy="91441"/>
              </a:xfrm>
              <a:prstGeom prst="ellipse">
                <a:avLst/>
              </a:prstGeom>
              <a:solidFill>
                <a:srgbClr val="00B05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772" dirty="0"/>
              </a:p>
            </p:txBody>
          </p:sp>
          <p:sp>
            <p:nvSpPr>
              <p:cNvPr id="20" name="Oval 19">
                <a:extLst>
                  <a:ext uri="{FF2B5EF4-FFF2-40B4-BE49-F238E27FC236}">
                    <a16:creationId xmlns:a16="http://schemas.microsoft.com/office/drawing/2014/main" id="{4BFF9C6C-77B1-DBD7-8946-EDF54D5BE8C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9986510" y="2557805"/>
                <a:ext cx="91440" cy="91441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772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D807D3C-0A5F-3019-9C4A-1E6143A91D79}"/>
                  </a:ext>
                </a:extLst>
              </p:cNvPr>
              <p:cNvSpPr txBox="1"/>
              <p:nvPr/>
            </p:nvSpPr>
            <p:spPr>
              <a:xfrm>
                <a:off x="10059662" y="2381624"/>
                <a:ext cx="632026" cy="4015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78" b="1" dirty="0"/>
                  <a:t>TM-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4AD3DF5-7B95-CE7A-2FE3-EEE29B70A22B}"/>
                  </a:ext>
                </a:extLst>
              </p:cNvPr>
              <p:cNvSpPr txBox="1"/>
              <p:nvPr/>
            </p:nvSpPr>
            <p:spPr>
              <a:xfrm>
                <a:off x="10059662" y="2620490"/>
                <a:ext cx="678036" cy="4015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78" b="1" dirty="0"/>
                  <a:t>TM+</a:t>
                </a:r>
              </a:p>
            </p:txBody>
          </p:sp>
        </p:grp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8324CBB-0445-35BB-6F6F-CD5C68641D27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53384" y="3871122"/>
              <a:ext cx="277596" cy="3095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72" b="1" dirty="0"/>
                <a:t>D</a:t>
              </a:r>
            </a:p>
          </p:txBody>
        </p: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DAAA0517-1CFA-6731-796A-EA7AC8EC033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826707" y="825787"/>
              <a:ext cx="2873254" cy="1480566"/>
              <a:chOff x="2186351" y="215742"/>
              <a:chExt cx="3437986" cy="1771564"/>
            </a:xfrm>
          </p:grpSpPr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B187BFC0-0D34-FE30-C057-4E8FE81FCBB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186351" y="215742"/>
                <a:ext cx="3361039" cy="1532234"/>
                <a:chOff x="655663" y="3130659"/>
                <a:chExt cx="3970311" cy="1809992"/>
              </a:xfrm>
            </p:grpSpPr>
            <p:sp>
              <p:nvSpPr>
                <p:cNvPr id="39" name="TextBox 7">
                  <a:extLst>
                    <a:ext uri="{FF2B5EF4-FFF2-40B4-BE49-F238E27FC236}">
                      <a16:creationId xmlns:a16="http://schemas.microsoft.com/office/drawing/2014/main" id="{B63CEA94-BDEA-E3E0-2755-3857049FBCD5}"/>
                    </a:ext>
                  </a:extLst>
                </p:cNvPr>
                <p:cNvSpPr txBox="1"/>
                <p:nvPr/>
              </p:nvSpPr>
              <p:spPr>
                <a:xfrm>
                  <a:off x="1311097" y="3130659"/>
                  <a:ext cx="627152" cy="3966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378" b="1" dirty="0"/>
                    <a:t>TM-</a:t>
                  </a:r>
                </a:p>
              </p:txBody>
            </p:sp>
            <p:sp>
              <p:nvSpPr>
                <p:cNvPr id="40" name="TextBox 8">
                  <a:extLst>
                    <a:ext uri="{FF2B5EF4-FFF2-40B4-BE49-F238E27FC236}">
                      <a16:creationId xmlns:a16="http://schemas.microsoft.com/office/drawing/2014/main" id="{F721A785-B423-9794-F86B-73D0C6311C42}"/>
                    </a:ext>
                  </a:extLst>
                </p:cNvPr>
                <p:cNvSpPr txBox="1"/>
                <p:nvPr/>
              </p:nvSpPr>
              <p:spPr>
                <a:xfrm>
                  <a:off x="3324640" y="3130659"/>
                  <a:ext cx="671023" cy="39668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378" b="1" dirty="0"/>
                    <a:t>TM+</a:t>
                  </a:r>
                </a:p>
              </p:txBody>
            </p: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8CD227C9-EAFD-94AD-FCD5-06D06D9F6464}"/>
                    </a:ext>
                  </a:extLst>
                </p:cNvPr>
                <p:cNvGrpSpPr>
                  <a:grpSpLocks noChangeAspect="1"/>
                </p:cNvGrpSpPr>
                <p:nvPr/>
              </p:nvGrpSpPr>
              <p:grpSpPr>
                <a:xfrm>
                  <a:off x="655663" y="3493747"/>
                  <a:ext cx="3970311" cy="1446904"/>
                  <a:chOff x="553901" y="3748432"/>
                  <a:chExt cx="4962893" cy="1808630"/>
                </a:xfrm>
              </p:grpSpPr>
              <p:pic>
                <p:nvPicPr>
                  <p:cNvPr id="42" name="Picture 41">
                    <a:extLst>
                      <a:ext uri="{FF2B5EF4-FFF2-40B4-BE49-F238E27FC236}">
                        <a16:creationId xmlns:a16="http://schemas.microsoft.com/office/drawing/2014/main" id="{E6261B71-6AF0-EE0B-8FFA-C156900C980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817" t="354" r="3564" b="-1896"/>
                  <a:stretch/>
                </p:blipFill>
                <p:spPr>
                  <a:xfrm>
                    <a:off x="553901" y="3748432"/>
                    <a:ext cx="2452255" cy="1808630"/>
                  </a:xfrm>
                  <a:prstGeom prst="rect">
                    <a:avLst/>
                  </a:prstGeom>
                </p:spPr>
              </p:pic>
              <p:pic>
                <p:nvPicPr>
                  <p:cNvPr id="43" name="Picture 42">
                    <a:extLst>
                      <a:ext uri="{FF2B5EF4-FFF2-40B4-BE49-F238E27FC236}">
                        <a16:creationId xmlns:a16="http://schemas.microsoft.com/office/drawing/2014/main" id="{6EFD8336-838F-5A57-B03C-26A7688870B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752" r="11223"/>
                  <a:stretch/>
                </p:blipFill>
                <p:spPr>
                  <a:xfrm>
                    <a:off x="3064539" y="3748432"/>
                    <a:ext cx="2452255" cy="1777232"/>
                  </a:xfrm>
                  <a:prstGeom prst="rect">
                    <a:avLst/>
                  </a:prstGeom>
                </p:spPr>
              </p:pic>
            </p:grpSp>
          </p:grp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BB6E6777-F5C2-57BE-39BB-50D0B93462EC}"/>
                  </a:ext>
                </a:extLst>
              </p:cNvPr>
              <p:cNvCxnSpPr/>
              <p:nvPr/>
            </p:nvCxnSpPr>
            <p:spPr>
              <a:xfrm>
                <a:off x="5151238" y="1771605"/>
                <a:ext cx="392906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27819415-3983-E257-7178-4EE71E706721}"/>
                  </a:ext>
                </a:extLst>
              </p:cNvPr>
              <p:cNvSpPr txBox="1"/>
              <p:nvPr/>
            </p:nvSpPr>
            <p:spPr>
              <a:xfrm>
                <a:off x="4985545" y="1718208"/>
                <a:ext cx="638792" cy="2690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85" b="1" dirty="0"/>
                  <a:t>200 µm</a:t>
                </a:r>
              </a:p>
            </p:txBody>
          </p:sp>
        </p:grp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1E2A7CBF-AB34-4464-7DC9-3BC68DF64DE4}"/>
                </a:ext>
              </a:extLst>
            </p:cNvPr>
            <p:cNvCxnSpPr>
              <a:cxnSpLocks/>
            </p:cNvCxnSpPr>
            <p:nvPr/>
          </p:nvCxnSpPr>
          <p:spPr>
            <a:xfrm>
              <a:off x="912273" y="2488669"/>
              <a:ext cx="201168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A3BF054-E608-9EC2-4242-722710F8229C}"/>
                </a:ext>
              </a:extLst>
            </p:cNvPr>
            <p:cNvSpPr txBox="1"/>
            <p:nvPr/>
          </p:nvSpPr>
          <p:spPr>
            <a:xfrm>
              <a:off x="1528936" y="2226784"/>
              <a:ext cx="729082" cy="2502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78" b="1" dirty="0"/>
                <a:t>Temporal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9082FD4-5491-FCA1-46CC-C0F98F1D3F97}"/>
                </a:ext>
              </a:extLst>
            </p:cNvPr>
            <p:cNvSpPr txBox="1"/>
            <p:nvPr/>
          </p:nvSpPr>
          <p:spPr>
            <a:xfrm>
              <a:off x="2357996" y="2519176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1200" b="1" dirty="0">
                  <a:solidFill>
                    <a:srgbClr val="FF0000"/>
                  </a:solidFill>
                </a:rPr>
                <a:t>*</a:t>
              </a:r>
              <a:r>
                <a:rPr lang="en-US" sz="1200" b="1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F0060A5-DA05-463B-2271-889FED94D98F}"/>
                </a:ext>
              </a:extLst>
            </p:cNvPr>
            <p:cNvSpPr txBox="1"/>
            <p:nvPr/>
          </p:nvSpPr>
          <p:spPr>
            <a:xfrm>
              <a:off x="2130947" y="3685188"/>
              <a:ext cx="7922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0067</a:t>
              </a:r>
              <a:endParaRPr lang="en-US" sz="1100" b="1" i="1" dirty="0"/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0D608E72-F824-A7B7-B26F-4B134A45A86D}"/>
                </a:ext>
              </a:extLst>
            </p:cNvPr>
            <p:cNvCxnSpPr>
              <a:cxnSpLocks/>
            </p:cNvCxnSpPr>
            <p:nvPr/>
          </p:nvCxnSpPr>
          <p:spPr>
            <a:xfrm>
              <a:off x="3256914" y="2495004"/>
              <a:ext cx="196596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CA0F8EB-C872-BC7F-5DCA-B7D6416C7E48}"/>
                </a:ext>
              </a:extLst>
            </p:cNvPr>
            <p:cNvSpPr txBox="1"/>
            <p:nvPr/>
          </p:nvSpPr>
          <p:spPr>
            <a:xfrm>
              <a:off x="3958374" y="2222980"/>
              <a:ext cx="561705" cy="25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78" b="1" dirty="0"/>
                <a:t>Spatial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3294E381-52EE-5279-341E-7E57A47E4336}"/>
                </a:ext>
              </a:extLst>
            </p:cNvPr>
            <p:cNvCxnSpPr>
              <a:cxnSpLocks/>
            </p:cNvCxnSpPr>
            <p:nvPr/>
          </p:nvCxnSpPr>
          <p:spPr>
            <a:xfrm>
              <a:off x="933329" y="4165935"/>
              <a:ext cx="425196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5DFE521-E559-8ED4-343E-EC073C4B6D26}"/>
                </a:ext>
              </a:extLst>
            </p:cNvPr>
            <p:cNvSpPr txBox="1"/>
            <p:nvPr/>
          </p:nvSpPr>
          <p:spPr>
            <a:xfrm>
              <a:off x="2737823" y="3908695"/>
              <a:ext cx="560388" cy="250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378" b="1" dirty="0"/>
                <a:t>Others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3390F52-3535-4491-B97D-EEA43DAE0C61}"/>
                </a:ext>
              </a:extLst>
            </p:cNvPr>
            <p:cNvSpPr txBox="1"/>
            <p:nvPr/>
          </p:nvSpPr>
          <p:spPr>
            <a:xfrm>
              <a:off x="3459810" y="4202002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*</a:t>
              </a:r>
              <a:r>
                <a:rPr lang="zh-CN" altLang="en-US" sz="1200" b="1" dirty="0">
                  <a:solidFill>
                    <a:srgbClr val="FF0000"/>
                  </a:solidFill>
                </a:rPr>
                <a:t>**</a:t>
              </a:r>
              <a:endParaRPr lang="en-US" sz="1200" b="1" dirty="0">
                <a:solidFill>
                  <a:srgbClr val="FF0000"/>
                </a:solidFill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A14D8FA-AF08-36C1-B211-9045B2E7E018}"/>
                </a:ext>
              </a:extLst>
            </p:cNvPr>
            <p:cNvSpPr txBox="1"/>
            <p:nvPr/>
          </p:nvSpPr>
          <p:spPr>
            <a:xfrm>
              <a:off x="4629297" y="4202002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zh-CN" altLang="en-US" sz="1200" b="1" dirty="0">
                  <a:solidFill>
                    <a:srgbClr val="FF0000"/>
                  </a:solidFill>
                </a:rPr>
                <a:t>*</a:t>
              </a:r>
              <a:r>
                <a:rPr lang="en-US" sz="1200" b="1" dirty="0">
                  <a:solidFill>
                    <a:srgbClr val="FF0000"/>
                  </a:solidFill>
                </a:rPr>
                <a:t>*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EB8981A-1C65-206A-1E86-A827275428B2}"/>
                </a:ext>
              </a:extLst>
            </p:cNvPr>
            <p:cNvSpPr txBox="1"/>
            <p:nvPr/>
          </p:nvSpPr>
          <p:spPr>
            <a:xfrm>
              <a:off x="3227044" y="5360723"/>
              <a:ext cx="86433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00039</a:t>
              </a:r>
              <a:endParaRPr lang="en-US" sz="1100" b="1" i="1" dirty="0"/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33F6C964-B436-B5AA-63E2-5676BA4EADD2}"/>
                </a:ext>
              </a:extLst>
            </p:cNvPr>
            <p:cNvSpPr txBox="1"/>
            <p:nvPr/>
          </p:nvSpPr>
          <p:spPr>
            <a:xfrm>
              <a:off x="4432452" y="5360723"/>
              <a:ext cx="7922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0030</a:t>
              </a:r>
              <a:endParaRPr lang="en-US" sz="1100" b="1" i="1" dirty="0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3B70A149-D564-EC8C-FC16-30F003C8F64B}"/>
                </a:ext>
              </a:extLst>
            </p:cNvPr>
            <p:cNvSpPr txBox="1"/>
            <p:nvPr/>
          </p:nvSpPr>
          <p:spPr>
            <a:xfrm>
              <a:off x="3286731" y="5618528"/>
              <a:ext cx="732789" cy="3482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100"/>
                </a:lnSpc>
              </a:pPr>
              <a:r>
                <a:rPr lang="en-US" sz="1100" b="1" dirty="0"/>
                <a:t>Stride</a:t>
              </a:r>
            </a:p>
            <a:p>
              <a:pPr algn="ctr">
                <a:lnSpc>
                  <a:spcPts val="1100"/>
                </a:lnSpc>
              </a:pPr>
              <a:r>
                <a:rPr lang="en-US" sz="1100" b="1" dirty="0"/>
                <a:t>Frequency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2FFB725E-868C-EB92-9B7D-E8F0F5EEB23F}"/>
                </a:ext>
              </a:extLst>
            </p:cNvPr>
            <p:cNvSpPr txBox="1"/>
            <p:nvPr/>
          </p:nvSpPr>
          <p:spPr>
            <a:xfrm>
              <a:off x="964415" y="5724755"/>
              <a:ext cx="83548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Stride time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C0BE1768-389F-E1E3-23EE-B3D499506631}"/>
                </a:ext>
              </a:extLst>
            </p:cNvPr>
            <p:cNvSpPr txBox="1"/>
            <p:nvPr/>
          </p:nvSpPr>
          <p:spPr>
            <a:xfrm>
              <a:off x="1997786" y="5724755"/>
              <a:ext cx="889962" cy="2419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Stride Length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FD6C3A5-E106-E0F3-AC3A-6ED1EB3673A6}"/>
                </a:ext>
              </a:extLst>
            </p:cNvPr>
            <p:cNvSpPr txBox="1"/>
            <p:nvPr/>
          </p:nvSpPr>
          <p:spPr>
            <a:xfrm>
              <a:off x="4567853" y="5724755"/>
              <a:ext cx="44595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COG</a:t>
              </a:r>
            </a:p>
          </p:txBody>
        </p:sp>
        <p:grpSp>
          <p:nvGrpSpPr>
            <p:cNvPr id="60" name="Group 59">
              <a:extLst>
                <a:ext uri="{FF2B5EF4-FFF2-40B4-BE49-F238E27FC236}">
                  <a16:creationId xmlns:a16="http://schemas.microsoft.com/office/drawing/2014/main" id="{0BCC8D96-DA05-8A4A-BCF6-B355178BEEB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003078" y="5951193"/>
              <a:ext cx="468539" cy="368252"/>
              <a:chOff x="3193905" y="451098"/>
              <a:chExt cx="483413" cy="379942"/>
            </a:xfrm>
          </p:grpSpPr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9FE16BF2-D2BD-2F4E-BAE4-8A061E054EE6}"/>
                  </a:ext>
                </a:extLst>
              </p:cNvPr>
              <p:cNvSpPr/>
              <p:nvPr/>
            </p:nvSpPr>
            <p:spPr>
              <a:xfrm>
                <a:off x="3193905" y="530968"/>
                <a:ext cx="120795" cy="635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772"/>
              </a:p>
            </p:txBody>
          </p:sp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8A457C82-E510-484F-9521-84163EDC9A78}"/>
                  </a:ext>
                </a:extLst>
              </p:cNvPr>
              <p:cNvSpPr/>
              <p:nvPr/>
            </p:nvSpPr>
            <p:spPr>
              <a:xfrm>
                <a:off x="3193905" y="672807"/>
                <a:ext cx="120795" cy="63500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772"/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55329240-BEA8-0F43-971D-DCFD723AB3AC}"/>
                  </a:ext>
                </a:extLst>
              </p:cNvPr>
              <p:cNvSpPr txBox="1"/>
              <p:nvPr/>
            </p:nvSpPr>
            <p:spPr>
              <a:xfrm>
                <a:off x="3277843" y="451098"/>
                <a:ext cx="375372" cy="23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85" b="1" dirty="0"/>
                  <a:t>TM-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9FA1DD62-1E3A-8F4B-AED8-8A2D1A5E20EA}"/>
                  </a:ext>
                </a:extLst>
              </p:cNvPr>
              <p:cNvSpPr txBox="1"/>
              <p:nvPr/>
            </p:nvSpPr>
            <p:spPr>
              <a:xfrm>
                <a:off x="3277844" y="599671"/>
                <a:ext cx="399474" cy="2313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85" b="1" dirty="0"/>
                  <a:t>TM+</a:t>
                </a:r>
              </a:p>
            </p:txBody>
          </p:sp>
        </p:grp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FFA85F4-1192-D542-A95B-1EFF537EC6C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71670" y="807396"/>
              <a:ext cx="1165098" cy="1366266"/>
            </a:xfrm>
            <a:prstGeom prst="rect">
              <a:avLst/>
            </a:prstGeom>
          </p:spPr>
        </p:pic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CFD36C16-A7EA-5F4E-B525-1FDD54D8E134}"/>
                </a:ext>
              </a:extLst>
            </p:cNvPr>
            <p:cNvSpPr txBox="1"/>
            <p:nvPr/>
          </p:nvSpPr>
          <p:spPr>
            <a:xfrm>
              <a:off x="4076177" y="2064843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/>
                <a:t>p = 0.34 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03FAABE-EC1A-4A45-A9A4-3AE80C6576C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1558" y="2462872"/>
              <a:ext cx="1279525" cy="1345565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1EF149E-3211-6B43-8C7B-59B442EE12C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82231" y="2462872"/>
              <a:ext cx="1279525" cy="1345565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88283B1-4BD8-7646-8F8B-AF4308B6481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912385" y="2462872"/>
              <a:ext cx="1229995" cy="134556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BDFF133-90A9-E746-B336-82A9C1C0D02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066019" y="2462872"/>
              <a:ext cx="1254760" cy="1345565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3AADF600-51B0-B049-997B-AB9D56B6BCA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58061" y="4144198"/>
              <a:ext cx="1254760" cy="1345565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488BF95-CC72-4848-BFA2-8A7FFC969AB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715584" y="4144198"/>
              <a:ext cx="1221740" cy="1345565"/>
            </a:xfrm>
            <a:prstGeom prst="rect">
              <a:avLst/>
            </a:prstGeom>
          </p:spPr>
        </p:pic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E09F2FEB-B71F-BB4D-B551-506CF6D235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854532" y="4144198"/>
              <a:ext cx="1246505" cy="1345565"/>
            </a:xfrm>
            <a:prstGeom prst="rect">
              <a:avLst/>
            </a:prstGeom>
          </p:spPr>
        </p:pic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D0D84E69-F321-FC44-A627-E6D740426EA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041458" y="4144198"/>
              <a:ext cx="1221740" cy="1345565"/>
            </a:xfrm>
            <a:prstGeom prst="rect">
              <a:avLst/>
            </a:prstGeom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40699B17-9F06-A24A-938B-5996BEA5EE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t="15113"/>
            <a:stretch/>
          </p:blipFill>
          <p:spPr>
            <a:xfrm>
              <a:off x="646209" y="5904521"/>
              <a:ext cx="1155700" cy="1310388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96B644DA-B5B6-1A48-9253-08BEE474F6A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t="14759"/>
            <a:stretch/>
          </p:blipFill>
          <p:spPr>
            <a:xfrm>
              <a:off x="1767452" y="5904521"/>
              <a:ext cx="1155700" cy="1315853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E1BA2A4D-5DB8-BE48-A184-B2190C4BBF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t="14759"/>
            <a:stretch/>
          </p:blipFill>
          <p:spPr>
            <a:xfrm>
              <a:off x="2958692" y="5904521"/>
              <a:ext cx="1196975" cy="1315853"/>
            </a:xfrm>
            <a:prstGeom prst="rect">
              <a:avLst/>
            </a:prstGeom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8CED7F3B-D054-564B-83DC-22E3807A2D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t="14759"/>
            <a:stretch/>
          </p:blipFill>
          <p:spPr>
            <a:xfrm>
              <a:off x="4049635" y="5904521"/>
              <a:ext cx="1196975" cy="1315853"/>
            </a:xfrm>
            <a:prstGeom prst="rect">
              <a:avLst/>
            </a:prstGeom>
          </p:spPr>
        </p:pic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BC6FD00D-4CEB-CD45-9668-461A122FAAE4}"/>
                </a:ext>
              </a:extLst>
            </p:cNvPr>
            <p:cNvSpPr txBox="1"/>
            <p:nvPr/>
          </p:nvSpPr>
          <p:spPr>
            <a:xfrm>
              <a:off x="1042657" y="7120191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41</a:t>
              </a:r>
              <a:endParaRPr lang="en-US" sz="1100" b="1" i="1" dirty="0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1C33C2E3-732F-D84C-AE53-599637986A79}"/>
                </a:ext>
              </a:extLst>
            </p:cNvPr>
            <p:cNvSpPr txBox="1"/>
            <p:nvPr/>
          </p:nvSpPr>
          <p:spPr>
            <a:xfrm>
              <a:off x="2157344" y="7120191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41</a:t>
              </a:r>
              <a:endParaRPr lang="en-US" sz="1100" b="1" i="1" dirty="0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71F5BC39-011B-794F-9DF5-2DC13314BD3D}"/>
                </a:ext>
              </a:extLst>
            </p:cNvPr>
            <p:cNvSpPr txBox="1"/>
            <p:nvPr/>
          </p:nvSpPr>
          <p:spPr>
            <a:xfrm>
              <a:off x="3366161" y="7120191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37</a:t>
              </a:r>
              <a:endParaRPr lang="en-US" sz="1100" b="1" i="1" dirty="0"/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99C4950-E608-F748-92A6-51BC00236115}"/>
                </a:ext>
              </a:extLst>
            </p:cNvPr>
            <p:cNvSpPr txBox="1"/>
            <p:nvPr/>
          </p:nvSpPr>
          <p:spPr>
            <a:xfrm>
              <a:off x="4504587" y="7120191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41</a:t>
              </a:r>
              <a:endParaRPr lang="en-US" sz="1100" b="1" i="1" dirty="0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F6D16FB-2F32-934A-6B22-5825548452AC}"/>
                </a:ext>
              </a:extLst>
            </p:cNvPr>
            <p:cNvSpPr txBox="1"/>
            <p:nvPr/>
          </p:nvSpPr>
          <p:spPr>
            <a:xfrm>
              <a:off x="3371408" y="3685188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53</a:t>
              </a:r>
              <a:endParaRPr lang="en-US" sz="1100" b="1" i="1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B52C21E-AFCB-1FCF-AEBF-DC2234DCE4B8}"/>
                </a:ext>
              </a:extLst>
            </p:cNvPr>
            <p:cNvSpPr txBox="1"/>
            <p:nvPr/>
          </p:nvSpPr>
          <p:spPr>
            <a:xfrm>
              <a:off x="996356" y="5360723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57</a:t>
              </a:r>
              <a:endParaRPr lang="en-US" sz="1100" b="1" i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C100CD7-9811-CD4F-AB1E-D4F3DEB1206D}"/>
                </a:ext>
              </a:extLst>
            </p:cNvPr>
            <p:cNvSpPr txBox="1"/>
            <p:nvPr/>
          </p:nvSpPr>
          <p:spPr>
            <a:xfrm>
              <a:off x="2143765" y="5360723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68</a:t>
              </a:r>
              <a:endParaRPr lang="en-US" sz="1100" b="1" i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60DECDF-BD2D-16F0-C32A-B3B045DA0C79}"/>
                </a:ext>
              </a:extLst>
            </p:cNvPr>
            <p:cNvSpPr txBox="1"/>
            <p:nvPr/>
          </p:nvSpPr>
          <p:spPr>
            <a:xfrm>
              <a:off x="4513134" y="3685188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15</a:t>
              </a:r>
              <a:endParaRPr lang="en-US" sz="1100" b="1" i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D673BDA-B641-825F-0022-DF469652C71C}"/>
                </a:ext>
              </a:extLst>
            </p:cNvPr>
            <p:cNvSpPr txBox="1"/>
            <p:nvPr/>
          </p:nvSpPr>
          <p:spPr>
            <a:xfrm>
              <a:off x="1010252" y="3685188"/>
              <a:ext cx="6479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/>
                <a:t>p = </a:t>
              </a:r>
              <a:r>
                <a:rPr lang="en-US" altLang="zh-CN" sz="1100" b="1" i="1" dirty="0"/>
                <a:t>0.61</a:t>
              </a:r>
              <a:endParaRPr lang="en-US" sz="1100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97371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681</TotalTime>
  <Words>275</Words>
  <Application>Microsoft Office PowerPoint</Application>
  <PresentationFormat>Custom</PresentationFormat>
  <Paragraphs>9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Yajun</dc:creator>
  <cp:lastModifiedBy>Liu, Yajun</cp:lastModifiedBy>
  <cp:revision>298</cp:revision>
  <cp:lastPrinted>2024-01-11T14:41:22Z</cp:lastPrinted>
  <dcterms:created xsi:type="dcterms:W3CDTF">2023-11-28T15:58:56Z</dcterms:created>
  <dcterms:modified xsi:type="dcterms:W3CDTF">2026-02-15T18:01:39Z</dcterms:modified>
</cp:coreProperties>
</file>